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4" autoAdjust="0"/>
    <p:restoredTop sz="94660"/>
  </p:normalViewPr>
  <p:slideViewPr>
    <p:cSldViewPr snapToGrid="0">
      <p:cViewPr varScale="1">
        <p:scale>
          <a:sx n="77" d="100"/>
          <a:sy n="77" d="100"/>
        </p:scale>
        <p:origin x="12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18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530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580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1774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7332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0450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60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345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4082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0806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6646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B08D2-800D-4A90-AC08-2B28C2F5A17B}" type="datetimeFigureOut">
              <a:rPr lang="fr-FR" smtClean="0"/>
              <a:t>25/0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09FBF-F739-4B60-B62A-D7F7439921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858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6B298C73-929D-4052-98B9-D4A507A92FC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8" r="10782"/>
          <a:stretch/>
        </p:blipFill>
        <p:spPr>
          <a:xfrm>
            <a:off x="107606" y="355677"/>
            <a:ext cx="3149930" cy="2946502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1278504B-6AD3-4D9A-A941-0215D95C54C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3429000" y="330625"/>
            <a:ext cx="3150013" cy="2946502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F371BCE8-98AF-4F95-BA0C-69DC3149C64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107523" y="3477543"/>
            <a:ext cx="3150013" cy="2946502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53243988-B50D-4DCE-970B-7AA20A03344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3428999" y="3477543"/>
            <a:ext cx="3150013" cy="2946502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3B1B89C2-C7A2-499C-8FA9-C5A3875E5C0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107523" y="6706372"/>
            <a:ext cx="3150013" cy="2946502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AA4B425D-109E-4C72-A6B9-5C01FFB3C51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3428998" y="6706372"/>
            <a:ext cx="3150013" cy="2946502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2CBB8C77-511A-416B-8D2F-0EF66B5B444E}"/>
              </a:ext>
            </a:extLst>
          </p:cNvPr>
          <p:cNvSpPr txBox="1"/>
          <p:nvPr/>
        </p:nvSpPr>
        <p:spPr>
          <a:xfrm>
            <a:off x="942711" y="9768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1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421166A-7C92-4C6E-8ACF-E2BF2B5DB7A3}"/>
              </a:ext>
            </a:extLst>
          </p:cNvPr>
          <p:cNvSpPr txBox="1"/>
          <p:nvPr/>
        </p:nvSpPr>
        <p:spPr>
          <a:xfrm>
            <a:off x="4264186" y="9191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2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31283EEE-025D-4ED4-9EEB-BAB2897D4983}"/>
              </a:ext>
            </a:extLst>
          </p:cNvPr>
          <p:cNvSpPr txBox="1"/>
          <p:nvPr/>
        </p:nvSpPr>
        <p:spPr>
          <a:xfrm>
            <a:off x="942711" y="326965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3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CB419BF9-96D5-4764-BE0A-96C2141A5042}"/>
              </a:ext>
            </a:extLst>
          </p:cNvPr>
          <p:cNvSpPr txBox="1"/>
          <p:nvPr/>
        </p:nvSpPr>
        <p:spPr>
          <a:xfrm>
            <a:off x="4264186" y="326388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4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7A4A65EA-028E-4B69-8ACC-644FBFAA4422}"/>
              </a:ext>
            </a:extLst>
          </p:cNvPr>
          <p:cNvSpPr txBox="1"/>
          <p:nvPr/>
        </p:nvSpPr>
        <p:spPr>
          <a:xfrm>
            <a:off x="942711" y="6467284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5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255CE630-079B-471A-8D51-98B7B3D76C53}"/>
              </a:ext>
            </a:extLst>
          </p:cNvPr>
          <p:cNvSpPr txBox="1"/>
          <p:nvPr/>
        </p:nvSpPr>
        <p:spPr>
          <a:xfrm>
            <a:off x="4264186" y="6461514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6</a:t>
            </a:r>
          </a:p>
        </p:txBody>
      </p:sp>
    </p:spTree>
    <p:extLst>
      <p:ext uri="{BB962C8B-B14F-4D97-AF65-F5344CB8AC3E}">
        <p14:creationId xmlns:p14="http://schemas.microsoft.com/office/powerpoint/2010/main" val="325664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85D0C392-CC0B-4BCB-B1AA-0F670387A3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157711" y="380729"/>
            <a:ext cx="3150013" cy="2946502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7FFF00FE-FD1F-40DC-B310-52184550772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3429000" y="380729"/>
            <a:ext cx="3150013" cy="2946502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D9DE8091-B54F-4D80-BAC1-259EB059904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157711" y="3567431"/>
            <a:ext cx="3150013" cy="2946502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7463182C-E5D0-4B02-A6CD-303D14CACAF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7" r="10781"/>
          <a:stretch/>
        </p:blipFill>
        <p:spPr>
          <a:xfrm>
            <a:off x="3550276" y="3567431"/>
            <a:ext cx="3150013" cy="2946502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2A387746-693D-4750-94D9-64C2C580DAF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58" r="9619"/>
          <a:stretch/>
        </p:blipFill>
        <p:spPr>
          <a:xfrm>
            <a:off x="1912293" y="6660794"/>
            <a:ext cx="3275966" cy="3245206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7154BBA1-85AE-4635-8461-6A7B7C0025D7}"/>
              </a:ext>
            </a:extLst>
          </p:cNvPr>
          <p:cNvSpPr txBox="1"/>
          <p:nvPr/>
        </p:nvSpPr>
        <p:spPr>
          <a:xfrm>
            <a:off x="942711" y="9768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7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4CA07F5C-102B-4AD9-B3B6-13E87EB9B48D}"/>
              </a:ext>
            </a:extLst>
          </p:cNvPr>
          <p:cNvSpPr txBox="1"/>
          <p:nvPr/>
        </p:nvSpPr>
        <p:spPr>
          <a:xfrm>
            <a:off x="4264186" y="91918"/>
            <a:ext cx="14443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8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55ABA06-D933-4C30-BE52-929510F0147E}"/>
              </a:ext>
            </a:extLst>
          </p:cNvPr>
          <p:cNvSpPr txBox="1"/>
          <p:nvPr/>
        </p:nvSpPr>
        <p:spPr>
          <a:xfrm>
            <a:off x="1028445" y="3351979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9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B140EDA-D9FE-4B5B-AC83-ECFF1BBF3C5D}"/>
              </a:ext>
            </a:extLst>
          </p:cNvPr>
          <p:cNvSpPr txBox="1"/>
          <p:nvPr/>
        </p:nvSpPr>
        <p:spPr>
          <a:xfrm>
            <a:off x="4349920" y="3346209"/>
            <a:ext cx="15581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10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AB653FAC-8C80-4CFC-A168-4ED29EB39AD1}"/>
              </a:ext>
            </a:extLst>
          </p:cNvPr>
          <p:cNvSpPr txBox="1"/>
          <p:nvPr/>
        </p:nvSpPr>
        <p:spPr>
          <a:xfrm>
            <a:off x="2949092" y="6440270"/>
            <a:ext cx="996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entroid Size</a:t>
            </a:r>
          </a:p>
        </p:txBody>
      </p:sp>
    </p:spTree>
    <p:extLst>
      <p:ext uri="{BB962C8B-B14F-4D97-AF65-F5344CB8AC3E}">
        <p14:creationId xmlns:p14="http://schemas.microsoft.com/office/powerpoint/2010/main" val="1496065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81947A2A-C148-49A7-932D-1708361B1C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7660"/>
            <a:ext cx="3429000" cy="20574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540A72C2-6894-4F3E-87A0-EFFCD8F6DE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77660"/>
            <a:ext cx="3429000" cy="20574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4372F26C-9B33-4715-B880-7780F69C79D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95600"/>
            <a:ext cx="3429000" cy="20574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05C72E66-0E4F-4F1C-A657-92184B60426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895600"/>
            <a:ext cx="3429000" cy="20574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B1933C9B-EB03-4AF0-84DA-7E4A9305AE3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39841"/>
            <a:ext cx="3429000" cy="2057400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257EC18E-E089-4468-9EB5-1614A2C5878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132" y="6123140"/>
            <a:ext cx="3429000" cy="2057400"/>
          </a:xfrm>
          <a:prstGeom prst="rect">
            <a:avLst/>
          </a:prstGeom>
        </p:spPr>
      </p:pic>
      <p:sp>
        <p:nvSpPr>
          <p:cNvPr id="16" name="ZoneTexte 15">
            <a:extLst>
              <a:ext uri="{FF2B5EF4-FFF2-40B4-BE49-F238E27FC236}">
                <a16:creationId xmlns:a16="http://schemas.microsoft.com/office/drawing/2014/main" id="{725400F1-8080-49C2-90A7-0ACBF336DAD0}"/>
              </a:ext>
            </a:extLst>
          </p:cNvPr>
          <p:cNvSpPr txBox="1"/>
          <p:nvPr/>
        </p:nvSpPr>
        <p:spPr>
          <a:xfrm>
            <a:off x="942711" y="9768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1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93D557E4-FBB0-4548-89AB-8E8F16266912}"/>
              </a:ext>
            </a:extLst>
          </p:cNvPr>
          <p:cNvSpPr txBox="1"/>
          <p:nvPr/>
        </p:nvSpPr>
        <p:spPr>
          <a:xfrm>
            <a:off x="4264186" y="9191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DC9B9A1-859D-4B3E-9226-C1A8B889197E}"/>
              </a:ext>
            </a:extLst>
          </p:cNvPr>
          <p:cNvSpPr txBox="1"/>
          <p:nvPr/>
        </p:nvSpPr>
        <p:spPr>
          <a:xfrm>
            <a:off x="1030393" y="2590799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3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0D0E86D4-03D3-49B6-AE8F-01B50E1F968A}"/>
              </a:ext>
            </a:extLst>
          </p:cNvPr>
          <p:cNvSpPr txBox="1"/>
          <p:nvPr/>
        </p:nvSpPr>
        <p:spPr>
          <a:xfrm>
            <a:off x="4351868" y="2585029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4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580DE0A8-2355-4D90-97E4-D3023CDA5E15}"/>
              </a:ext>
            </a:extLst>
          </p:cNvPr>
          <p:cNvSpPr txBox="1"/>
          <p:nvPr/>
        </p:nvSpPr>
        <p:spPr>
          <a:xfrm>
            <a:off x="942711" y="5846141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5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B833DD0-4D60-4AE2-853C-EDD6049497B0}"/>
              </a:ext>
            </a:extLst>
          </p:cNvPr>
          <p:cNvSpPr txBox="1"/>
          <p:nvPr/>
        </p:nvSpPr>
        <p:spPr>
          <a:xfrm>
            <a:off x="4264186" y="5840371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6</a:t>
            </a:r>
          </a:p>
        </p:txBody>
      </p:sp>
    </p:spTree>
    <p:extLst>
      <p:ext uri="{BB962C8B-B14F-4D97-AF65-F5344CB8AC3E}">
        <p14:creationId xmlns:p14="http://schemas.microsoft.com/office/powerpoint/2010/main" val="41771598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146D792C-912F-49BB-9EEE-64FA9F10ED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5759"/>
            <a:ext cx="3429000" cy="20574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9D0ED98D-CA8A-4E4C-96DF-63315E18EE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65759"/>
            <a:ext cx="3429000" cy="20574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479F1D22-83D8-4543-915F-1D5967D104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34218"/>
            <a:ext cx="3429000" cy="20574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4568A09D-54EB-43CA-B2A3-84DAE4F4ED3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434218"/>
            <a:ext cx="3429000" cy="20574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5807E05E-E544-4C99-BA2D-D79A41471F3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4500" y="6189945"/>
            <a:ext cx="3429000" cy="2057400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5199F816-0C8D-4F20-B8D4-9E69312F6EFB}"/>
              </a:ext>
            </a:extLst>
          </p:cNvPr>
          <p:cNvSpPr txBox="1"/>
          <p:nvPr/>
        </p:nvSpPr>
        <p:spPr>
          <a:xfrm>
            <a:off x="942711" y="97688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7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D572220-E94F-446E-B099-123895DF03DD}"/>
              </a:ext>
            </a:extLst>
          </p:cNvPr>
          <p:cNvSpPr txBox="1"/>
          <p:nvPr/>
        </p:nvSpPr>
        <p:spPr>
          <a:xfrm>
            <a:off x="4264186" y="91918"/>
            <a:ext cx="14443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8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3E4EC4CD-9528-4102-A0E5-D8628D65F015}"/>
              </a:ext>
            </a:extLst>
          </p:cNvPr>
          <p:cNvSpPr txBox="1"/>
          <p:nvPr/>
        </p:nvSpPr>
        <p:spPr>
          <a:xfrm>
            <a:off x="974682" y="3047426"/>
            <a:ext cx="14796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9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46EDB35C-6E3A-4A0F-B4F9-F088C74458B2}"/>
              </a:ext>
            </a:extLst>
          </p:cNvPr>
          <p:cNvSpPr txBox="1"/>
          <p:nvPr/>
        </p:nvSpPr>
        <p:spPr>
          <a:xfrm>
            <a:off x="4325135" y="3010946"/>
            <a:ext cx="15581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mmarized shape 10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0E741949-E550-4FE2-9820-BF07C1C5339A}"/>
              </a:ext>
            </a:extLst>
          </p:cNvPr>
          <p:cNvSpPr txBox="1"/>
          <p:nvPr/>
        </p:nvSpPr>
        <p:spPr>
          <a:xfrm>
            <a:off x="2930786" y="5776390"/>
            <a:ext cx="996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entroid Size</a:t>
            </a:r>
          </a:p>
        </p:txBody>
      </p:sp>
    </p:spTree>
    <p:extLst>
      <p:ext uri="{BB962C8B-B14F-4D97-AF65-F5344CB8AC3E}">
        <p14:creationId xmlns:p14="http://schemas.microsoft.com/office/powerpoint/2010/main" val="39924344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</TotalTime>
  <Words>62</Words>
  <Application>Microsoft Office PowerPoint</Application>
  <PresentationFormat>Format A4 (210 x 297 mm)</PresentationFormat>
  <Paragraphs>22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Ricard</dc:creator>
  <cp:lastModifiedBy>Anne Ricard</cp:lastModifiedBy>
  <cp:revision>16</cp:revision>
  <dcterms:created xsi:type="dcterms:W3CDTF">2023-01-20T15:30:57Z</dcterms:created>
  <dcterms:modified xsi:type="dcterms:W3CDTF">2023-01-25T17:45:18Z</dcterms:modified>
</cp:coreProperties>
</file>